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10"/>
  </p:notesMasterIdLst>
  <p:sldIdLst>
    <p:sldId id="256" r:id="rId2"/>
    <p:sldId id="292" r:id="rId3"/>
    <p:sldId id="293" r:id="rId4"/>
    <p:sldId id="262" r:id="rId5"/>
    <p:sldId id="270" r:id="rId6"/>
    <p:sldId id="294" r:id="rId7"/>
    <p:sldId id="288" r:id="rId8"/>
    <p:sldId id="260" r:id="rId9"/>
  </p:sldIdLst>
  <p:sldSz cx="10393363" cy="12617450"/>
  <p:notesSz cx="6858000" cy="9144000"/>
  <p:defaultTextStyle>
    <a:defPPr>
      <a:defRPr lang="en-US"/>
    </a:defPPr>
    <a:lvl1pPr marL="0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1pPr>
    <a:lvl2pPr marL="525048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2pPr>
    <a:lvl3pPr marL="1050097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3pPr>
    <a:lvl4pPr marL="1575145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4pPr>
    <a:lvl5pPr marL="2100194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5pPr>
    <a:lvl6pPr marL="2625242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6pPr>
    <a:lvl7pPr marL="3150291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7pPr>
    <a:lvl8pPr marL="3675339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8pPr>
    <a:lvl9pPr marL="4200388" algn="l" defTabSz="1050097" rtl="0" eaLnBrk="1" latinLnBrk="0" hangingPunct="1">
      <a:defRPr sz="206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13" userDrawn="1">
          <p15:clr>
            <a:srgbClr val="A4A3A4"/>
          </p15:clr>
        </p15:guide>
        <p15:guide id="2" pos="1641" userDrawn="1">
          <p15:clr>
            <a:srgbClr val="A4A3A4"/>
          </p15:clr>
        </p15:guide>
        <p15:guide id="4" pos="756" userDrawn="1">
          <p15:clr>
            <a:srgbClr val="A4A3A4"/>
          </p15:clr>
        </p15:guide>
        <p15:guide id="5" pos="2502" userDrawn="1">
          <p15:clr>
            <a:srgbClr val="A4A3A4"/>
          </p15:clr>
        </p15:guide>
        <p15:guide id="6" pos="1935" userDrawn="1">
          <p15:clr>
            <a:srgbClr val="A4A3A4"/>
          </p15:clr>
        </p15:guide>
        <p15:guide id="7" orient="horz" pos="5221" userDrawn="1">
          <p15:clr>
            <a:srgbClr val="A4A3A4"/>
          </p15:clr>
        </p15:guide>
        <p15:guide id="8" orient="horz" pos="1670" userDrawn="1">
          <p15:clr>
            <a:srgbClr val="A4A3A4"/>
          </p15:clr>
        </p15:guide>
        <p15:guide id="9" orient="horz" pos="806" userDrawn="1">
          <p15:clr>
            <a:srgbClr val="A4A3A4"/>
          </p15:clr>
        </p15:guide>
        <p15:guide id="10" orient="horz" pos="3830" userDrawn="1">
          <p15:clr>
            <a:srgbClr val="A4A3A4"/>
          </p15:clr>
        </p15:guide>
        <p15:guide id="11" orient="horz" pos="6998" userDrawn="1">
          <p15:clr>
            <a:srgbClr val="A4A3A4"/>
          </p15:clr>
        </p15:guide>
        <p15:guide id="12" pos="3500" userDrawn="1">
          <p15:clr>
            <a:srgbClr val="A4A3A4"/>
          </p15:clr>
        </p15:guide>
        <p15:guide id="13" orient="horz" pos="2386" userDrawn="1">
          <p15:clr>
            <a:srgbClr val="A4A3A4"/>
          </p15:clr>
        </p15:guide>
        <p15:guide id="14" pos="3274" userDrawn="1">
          <p15:clr>
            <a:srgbClr val="A4A3A4"/>
          </p15:clr>
        </p15:guide>
        <p15:guide id="15" orient="horz" pos="6110" userDrawn="1">
          <p15:clr>
            <a:srgbClr val="A4A3A4"/>
          </p15:clr>
        </p15:guide>
        <p15:guide id="16" pos="4642" userDrawn="1">
          <p15:clr>
            <a:srgbClr val="A4A3A4"/>
          </p15:clr>
        </p15:guide>
        <p15:guide id="17" pos="3898" userDrawn="1">
          <p15:clr>
            <a:srgbClr val="A4A3A4"/>
          </p15:clr>
        </p15:guide>
        <p15:guide id="18" pos="5972" userDrawn="1">
          <p15:clr>
            <a:srgbClr val="A4A3A4"/>
          </p15:clr>
        </p15:guide>
        <p15:guide id="19" pos="54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734"/>
    <p:restoredTop sz="91311" autoAdjust="0"/>
  </p:normalViewPr>
  <p:slideViewPr>
    <p:cSldViewPr snapToGrid="0" snapToObjects="1" showGuides="1">
      <p:cViewPr>
        <p:scale>
          <a:sx n="79" d="100"/>
          <a:sy n="79" d="100"/>
        </p:scale>
        <p:origin x="1718" y="-101"/>
      </p:cViewPr>
      <p:guideLst>
        <p:guide orient="horz" pos="2613"/>
        <p:guide pos="1641"/>
        <p:guide pos="756"/>
        <p:guide pos="2502"/>
        <p:guide pos="1935"/>
        <p:guide orient="horz" pos="5221"/>
        <p:guide orient="horz" pos="1670"/>
        <p:guide orient="horz" pos="806"/>
        <p:guide orient="horz" pos="3830"/>
        <p:guide orient="horz" pos="6998"/>
        <p:guide pos="3500"/>
        <p:guide orient="horz" pos="2386"/>
        <p:guide pos="3274"/>
        <p:guide orient="horz" pos="6110"/>
        <p:guide pos="4642"/>
        <p:guide pos="3898"/>
        <p:guide pos="5972"/>
        <p:guide pos="543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3D8E16-F517-4746-83B9-341BC2A400E9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57413" y="1143000"/>
            <a:ext cx="25431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F1C013-259B-0144-A85D-6FEC1371851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026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1pPr>
    <a:lvl2pPr marL="525048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2pPr>
    <a:lvl3pPr marL="1050097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3pPr>
    <a:lvl4pPr marL="1575145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4pPr>
    <a:lvl5pPr marL="2100194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5pPr>
    <a:lvl6pPr marL="2625242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6pPr>
    <a:lvl7pPr marL="3150291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7pPr>
    <a:lvl8pPr marL="3675339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8pPr>
    <a:lvl9pPr marL="4200388" algn="l" defTabSz="1050097" rtl="0" eaLnBrk="1" latinLnBrk="0" hangingPunct="1">
      <a:defRPr sz="13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9753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5009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378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</a:t>
            </a:r>
            <a:r>
              <a:rPr lang="en-GB" sz="1378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A: Frequencies of naïve, central memory, effector memory and terminally differentiated CD4</a:t>
            </a:r>
            <a:r>
              <a:rPr lang="en-GB" sz="1378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GB" sz="1378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 cells stratified by age groups between WB+ and WB- women in the peripheral blood (14 - &lt;25 WB+ n=4, 14 - &lt;25 WB- n=12, 25 - &lt;45WB+ n=16, 25 - &lt;45WB- n=8, 45 - &lt;65WB+ n=6, 45 - &lt;65WB- n=5).  Groups were compared using Mann-Whitney U-test.    </a:t>
            </a:r>
            <a:endParaRPr lang="en-US" sz="1378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T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61603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5009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/>
              <a:t>Figure S2</a:t>
            </a:r>
            <a:r>
              <a:rPr lang="en-GB" sz="1200" dirty="0"/>
              <a:t>: Gating strategy for peripheral blood </a:t>
            </a:r>
            <a:r>
              <a:rPr lang="en-GB" sz="1200" dirty="0">
                <a:latin typeface="Aptos" panose="020B0004020202020204" pitchFamily="34" charset="0"/>
                <a:cs typeface="Times New Roman" panose="02020603050405020304" pitchFamily="18" charset="0"/>
              </a:rPr>
              <a:t>CCR5</a:t>
            </a:r>
            <a:r>
              <a:rPr lang="en-GB" sz="1200" dirty="0"/>
              <a:t> on total and memory CD4 T cells</a:t>
            </a:r>
            <a:endParaRPr lang="en-TZ" sz="1200" dirty="0"/>
          </a:p>
          <a:p>
            <a:endParaRPr lang="en-T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345679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5009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equencies of CD4 T cells expressing CCR5 in the cervical mucosal categorised by age.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requencies of CD4 T cells expressing CCR5</a:t>
            </a: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A), memory CD4 T cells expressing CCR5 (B) and activated memory CD4 T cells expressing CCR5 (C) between WB+ and WB- among three age groups: 14- &lt;25 (n=3 WB+, 7 WB-), 25-&lt;45 (n=15 WB+, 8 WB-) and 45-&lt;65 (n= 5 WB+, 2 WB-). Groups were compared using Mann-Whitney U-test.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378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01662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378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. Mean Fluorescence Intensity (MFI) of CCR5+ in relation to </a:t>
            </a:r>
            <a:r>
              <a:rPr lang="en-GB" sz="1378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B</a:t>
            </a:r>
            <a:r>
              <a:rPr lang="en-GB" sz="1378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378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ection status</a:t>
            </a:r>
            <a:r>
              <a:rPr lang="en-GB" sz="1378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FI of CCR5+ in the total CD4 T cells (A) and in the memory CD4 T cells (B). Each grey square and blue diamond represent a participant and the horizontal line is the group median. Groups were compared using Mann-Whitney U-test. </a:t>
            </a:r>
            <a:endParaRPr lang="en-TZ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43398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5009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/>
              <a:t>Figure S5</a:t>
            </a:r>
            <a:r>
              <a:rPr lang="en-GB" sz="1200" dirty="0"/>
              <a:t>: Gating strategies for peripheral blood </a:t>
            </a:r>
            <a:r>
              <a:rPr lang="en-GB" sz="12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α4β7</a:t>
            </a:r>
            <a:r>
              <a:rPr lang="en-GB" sz="1200" dirty="0"/>
              <a:t> on total, memory and activated memory CD4 T cells</a:t>
            </a:r>
            <a:endParaRPr lang="en-TZ" sz="1200" dirty="0"/>
          </a:p>
          <a:p>
            <a:endParaRPr lang="en-T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59430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5009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 Frequencies of α4β7</a:t>
            </a: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4 T cells in cervical mucosal and peripheral blood in relation to </a:t>
            </a:r>
            <a:r>
              <a:rPr lang="en-GB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B</a:t>
            </a:r>
            <a:r>
              <a:rPr lang="en-GB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ection status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presentative flow plots and a graph comparing frequencies of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</a:rPr>
              <a:t>m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mory CD 4 T cells (A) and Memory activated CD4 T cells (B) expressing α4β7 in the cervical mucosa and peripheral blood from WB+ and WB- groups. Cx:WB+ n=23 , Cx:WB- n=17, Pb:WB+ n=26, and Pb:WB- n=25. Each grey square and blue diamond represent a participant and a horizontal line is the group median. Groups were compared using Mann-Whitney U-test.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3514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5009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7: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ating strategies for the mucosal CD4 T cells and the two populations of γδ T cells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378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F1C013-259B-0144-A85D-6FEC13718515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2361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9502" y="2064940"/>
            <a:ext cx="8834359" cy="4392742"/>
          </a:xfrm>
        </p:spPr>
        <p:txBody>
          <a:bodyPr anchor="b"/>
          <a:lstStyle>
            <a:lvl1pPr algn="ctr">
              <a:defRPr sz="68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99171" y="6627083"/>
            <a:ext cx="7795022" cy="3046295"/>
          </a:xfrm>
        </p:spPr>
        <p:txBody>
          <a:bodyPr/>
          <a:lstStyle>
            <a:lvl1pPr marL="0" indent="0" algn="ctr">
              <a:buNone/>
              <a:defRPr sz="2728"/>
            </a:lvl1pPr>
            <a:lvl2pPr marL="519654" indent="0" algn="ctr">
              <a:buNone/>
              <a:defRPr sz="2273"/>
            </a:lvl2pPr>
            <a:lvl3pPr marL="1039307" indent="0" algn="ctr">
              <a:buNone/>
              <a:defRPr sz="2046"/>
            </a:lvl3pPr>
            <a:lvl4pPr marL="1558961" indent="0" algn="ctr">
              <a:buNone/>
              <a:defRPr sz="1819"/>
            </a:lvl4pPr>
            <a:lvl5pPr marL="2078614" indent="0" algn="ctr">
              <a:buNone/>
              <a:defRPr sz="1819"/>
            </a:lvl5pPr>
            <a:lvl6pPr marL="2598268" indent="0" algn="ctr">
              <a:buNone/>
              <a:defRPr sz="1819"/>
            </a:lvl6pPr>
            <a:lvl7pPr marL="3117921" indent="0" algn="ctr">
              <a:buNone/>
              <a:defRPr sz="1819"/>
            </a:lvl7pPr>
            <a:lvl8pPr marL="3637575" indent="0" algn="ctr">
              <a:buNone/>
              <a:defRPr sz="1819"/>
            </a:lvl8pPr>
            <a:lvl9pPr marL="4157228" indent="0" algn="ctr">
              <a:buNone/>
              <a:defRPr sz="181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958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3065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37751" y="671762"/>
            <a:ext cx="2241069" cy="106927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4544" y="671762"/>
            <a:ext cx="6593290" cy="1069270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758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151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9131" y="3145604"/>
            <a:ext cx="8964276" cy="5248508"/>
          </a:xfrm>
        </p:spPr>
        <p:txBody>
          <a:bodyPr anchor="b"/>
          <a:lstStyle>
            <a:lvl1pPr>
              <a:defRPr sz="68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9131" y="8443765"/>
            <a:ext cx="8964276" cy="2760066"/>
          </a:xfrm>
        </p:spPr>
        <p:txBody>
          <a:bodyPr/>
          <a:lstStyle>
            <a:lvl1pPr marL="0" indent="0">
              <a:buNone/>
              <a:defRPr sz="2728">
                <a:solidFill>
                  <a:schemeClr val="tx1"/>
                </a:solidFill>
              </a:defRPr>
            </a:lvl1pPr>
            <a:lvl2pPr marL="519654" indent="0">
              <a:buNone/>
              <a:defRPr sz="2273">
                <a:solidFill>
                  <a:schemeClr val="tx1">
                    <a:tint val="75000"/>
                  </a:schemeClr>
                </a:solidFill>
              </a:defRPr>
            </a:lvl2pPr>
            <a:lvl3pPr marL="1039307" indent="0">
              <a:buNone/>
              <a:defRPr sz="2046">
                <a:solidFill>
                  <a:schemeClr val="tx1">
                    <a:tint val="75000"/>
                  </a:schemeClr>
                </a:solidFill>
              </a:defRPr>
            </a:lvl3pPr>
            <a:lvl4pPr marL="1558961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4pPr>
            <a:lvl5pPr marL="2078614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5pPr>
            <a:lvl6pPr marL="2598268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6pPr>
            <a:lvl7pPr marL="3117921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7pPr>
            <a:lvl8pPr marL="3637575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8pPr>
            <a:lvl9pPr marL="4157228" indent="0">
              <a:buNone/>
              <a:defRPr sz="18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296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4544" y="3358812"/>
            <a:ext cx="4417179" cy="800565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61640" y="3358812"/>
            <a:ext cx="4417179" cy="800565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9096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897" y="671765"/>
            <a:ext cx="8964276" cy="24387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5899" y="3093028"/>
            <a:ext cx="4396879" cy="1515846"/>
          </a:xfrm>
        </p:spPr>
        <p:txBody>
          <a:bodyPr anchor="b"/>
          <a:lstStyle>
            <a:lvl1pPr marL="0" indent="0">
              <a:buNone/>
              <a:defRPr sz="2728" b="1"/>
            </a:lvl1pPr>
            <a:lvl2pPr marL="519654" indent="0">
              <a:buNone/>
              <a:defRPr sz="2273" b="1"/>
            </a:lvl2pPr>
            <a:lvl3pPr marL="1039307" indent="0">
              <a:buNone/>
              <a:defRPr sz="2046" b="1"/>
            </a:lvl3pPr>
            <a:lvl4pPr marL="1558961" indent="0">
              <a:buNone/>
              <a:defRPr sz="1819" b="1"/>
            </a:lvl4pPr>
            <a:lvl5pPr marL="2078614" indent="0">
              <a:buNone/>
              <a:defRPr sz="1819" b="1"/>
            </a:lvl5pPr>
            <a:lvl6pPr marL="2598268" indent="0">
              <a:buNone/>
              <a:defRPr sz="1819" b="1"/>
            </a:lvl6pPr>
            <a:lvl7pPr marL="3117921" indent="0">
              <a:buNone/>
              <a:defRPr sz="1819" b="1"/>
            </a:lvl7pPr>
            <a:lvl8pPr marL="3637575" indent="0">
              <a:buNone/>
              <a:defRPr sz="1819" b="1"/>
            </a:lvl8pPr>
            <a:lvl9pPr marL="4157228" indent="0">
              <a:buNone/>
              <a:defRPr sz="181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5899" y="4608874"/>
            <a:ext cx="4396879" cy="67789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61641" y="3093028"/>
            <a:ext cx="4418533" cy="1515846"/>
          </a:xfrm>
        </p:spPr>
        <p:txBody>
          <a:bodyPr anchor="b"/>
          <a:lstStyle>
            <a:lvl1pPr marL="0" indent="0">
              <a:buNone/>
              <a:defRPr sz="2728" b="1"/>
            </a:lvl1pPr>
            <a:lvl2pPr marL="519654" indent="0">
              <a:buNone/>
              <a:defRPr sz="2273" b="1"/>
            </a:lvl2pPr>
            <a:lvl3pPr marL="1039307" indent="0">
              <a:buNone/>
              <a:defRPr sz="2046" b="1"/>
            </a:lvl3pPr>
            <a:lvl4pPr marL="1558961" indent="0">
              <a:buNone/>
              <a:defRPr sz="1819" b="1"/>
            </a:lvl4pPr>
            <a:lvl5pPr marL="2078614" indent="0">
              <a:buNone/>
              <a:defRPr sz="1819" b="1"/>
            </a:lvl5pPr>
            <a:lvl6pPr marL="2598268" indent="0">
              <a:buNone/>
              <a:defRPr sz="1819" b="1"/>
            </a:lvl6pPr>
            <a:lvl7pPr marL="3117921" indent="0">
              <a:buNone/>
              <a:defRPr sz="1819" b="1"/>
            </a:lvl7pPr>
            <a:lvl8pPr marL="3637575" indent="0">
              <a:buNone/>
              <a:defRPr sz="1819" b="1"/>
            </a:lvl8pPr>
            <a:lvl9pPr marL="4157228" indent="0">
              <a:buNone/>
              <a:defRPr sz="181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61641" y="4608874"/>
            <a:ext cx="4418533" cy="67789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0267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1402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0190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897" y="841163"/>
            <a:ext cx="3352130" cy="2944072"/>
          </a:xfrm>
        </p:spPr>
        <p:txBody>
          <a:bodyPr anchor="b"/>
          <a:lstStyle>
            <a:lvl1pPr>
              <a:defRPr sz="36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18533" y="1816682"/>
            <a:ext cx="5261640" cy="8966567"/>
          </a:xfrm>
        </p:spPr>
        <p:txBody>
          <a:bodyPr/>
          <a:lstStyle>
            <a:lvl1pPr>
              <a:defRPr sz="3637"/>
            </a:lvl1pPr>
            <a:lvl2pPr>
              <a:defRPr sz="3182"/>
            </a:lvl2pPr>
            <a:lvl3pPr>
              <a:defRPr sz="2728"/>
            </a:lvl3pPr>
            <a:lvl4pPr>
              <a:defRPr sz="2273"/>
            </a:lvl4pPr>
            <a:lvl5pPr>
              <a:defRPr sz="2273"/>
            </a:lvl5pPr>
            <a:lvl6pPr>
              <a:defRPr sz="2273"/>
            </a:lvl6pPr>
            <a:lvl7pPr>
              <a:defRPr sz="2273"/>
            </a:lvl7pPr>
            <a:lvl8pPr>
              <a:defRPr sz="2273"/>
            </a:lvl8pPr>
            <a:lvl9pPr>
              <a:defRPr sz="227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5897" y="3785235"/>
            <a:ext cx="3352130" cy="7012616"/>
          </a:xfrm>
        </p:spPr>
        <p:txBody>
          <a:bodyPr/>
          <a:lstStyle>
            <a:lvl1pPr marL="0" indent="0">
              <a:buNone/>
              <a:defRPr sz="1819"/>
            </a:lvl1pPr>
            <a:lvl2pPr marL="519654" indent="0">
              <a:buNone/>
              <a:defRPr sz="1591"/>
            </a:lvl2pPr>
            <a:lvl3pPr marL="1039307" indent="0">
              <a:buNone/>
              <a:defRPr sz="1364"/>
            </a:lvl3pPr>
            <a:lvl4pPr marL="1558961" indent="0">
              <a:buNone/>
              <a:defRPr sz="1137"/>
            </a:lvl4pPr>
            <a:lvl5pPr marL="2078614" indent="0">
              <a:buNone/>
              <a:defRPr sz="1137"/>
            </a:lvl5pPr>
            <a:lvl6pPr marL="2598268" indent="0">
              <a:buNone/>
              <a:defRPr sz="1137"/>
            </a:lvl6pPr>
            <a:lvl7pPr marL="3117921" indent="0">
              <a:buNone/>
              <a:defRPr sz="1137"/>
            </a:lvl7pPr>
            <a:lvl8pPr marL="3637575" indent="0">
              <a:buNone/>
              <a:defRPr sz="1137"/>
            </a:lvl8pPr>
            <a:lvl9pPr marL="4157228" indent="0">
              <a:buNone/>
              <a:defRPr sz="113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2438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897" y="841163"/>
            <a:ext cx="3352130" cy="2944072"/>
          </a:xfrm>
        </p:spPr>
        <p:txBody>
          <a:bodyPr anchor="b"/>
          <a:lstStyle>
            <a:lvl1pPr>
              <a:defRPr sz="36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18533" y="1816682"/>
            <a:ext cx="5261640" cy="8966567"/>
          </a:xfrm>
        </p:spPr>
        <p:txBody>
          <a:bodyPr anchor="t"/>
          <a:lstStyle>
            <a:lvl1pPr marL="0" indent="0">
              <a:buNone/>
              <a:defRPr sz="3637"/>
            </a:lvl1pPr>
            <a:lvl2pPr marL="519654" indent="0">
              <a:buNone/>
              <a:defRPr sz="3182"/>
            </a:lvl2pPr>
            <a:lvl3pPr marL="1039307" indent="0">
              <a:buNone/>
              <a:defRPr sz="2728"/>
            </a:lvl3pPr>
            <a:lvl4pPr marL="1558961" indent="0">
              <a:buNone/>
              <a:defRPr sz="2273"/>
            </a:lvl4pPr>
            <a:lvl5pPr marL="2078614" indent="0">
              <a:buNone/>
              <a:defRPr sz="2273"/>
            </a:lvl5pPr>
            <a:lvl6pPr marL="2598268" indent="0">
              <a:buNone/>
              <a:defRPr sz="2273"/>
            </a:lvl6pPr>
            <a:lvl7pPr marL="3117921" indent="0">
              <a:buNone/>
              <a:defRPr sz="2273"/>
            </a:lvl7pPr>
            <a:lvl8pPr marL="3637575" indent="0">
              <a:buNone/>
              <a:defRPr sz="2273"/>
            </a:lvl8pPr>
            <a:lvl9pPr marL="4157228" indent="0">
              <a:buNone/>
              <a:defRPr sz="227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5897" y="3785235"/>
            <a:ext cx="3352130" cy="7012616"/>
          </a:xfrm>
        </p:spPr>
        <p:txBody>
          <a:bodyPr/>
          <a:lstStyle>
            <a:lvl1pPr marL="0" indent="0">
              <a:buNone/>
              <a:defRPr sz="1819"/>
            </a:lvl1pPr>
            <a:lvl2pPr marL="519654" indent="0">
              <a:buNone/>
              <a:defRPr sz="1591"/>
            </a:lvl2pPr>
            <a:lvl3pPr marL="1039307" indent="0">
              <a:buNone/>
              <a:defRPr sz="1364"/>
            </a:lvl3pPr>
            <a:lvl4pPr marL="1558961" indent="0">
              <a:buNone/>
              <a:defRPr sz="1137"/>
            </a:lvl4pPr>
            <a:lvl5pPr marL="2078614" indent="0">
              <a:buNone/>
              <a:defRPr sz="1137"/>
            </a:lvl5pPr>
            <a:lvl6pPr marL="2598268" indent="0">
              <a:buNone/>
              <a:defRPr sz="1137"/>
            </a:lvl6pPr>
            <a:lvl7pPr marL="3117921" indent="0">
              <a:buNone/>
              <a:defRPr sz="1137"/>
            </a:lvl7pPr>
            <a:lvl8pPr marL="3637575" indent="0">
              <a:buNone/>
              <a:defRPr sz="1137"/>
            </a:lvl8pPr>
            <a:lvl9pPr marL="4157228" indent="0">
              <a:buNone/>
              <a:defRPr sz="113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177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4544" y="671765"/>
            <a:ext cx="8964276" cy="24387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4544" y="3358812"/>
            <a:ext cx="8964276" cy="80056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4544" y="11694510"/>
            <a:ext cx="2338507" cy="671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97E706-8ED3-5542-A9E3-D7137743D6FD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42802" y="11694510"/>
            <a:ext cx="3507760" cy="671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40312" y="11694510"/>
            <a:ext cx="2338507" cy="671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04CE7-E477-F241-9CB8-9C9690C91CB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0336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39307" rtl="0" eaLnBrk="1" latinLnBrk="0" hangingPunct="1">
        <a:lnSpc>
          <a:spcPct val="90000"/>
        </a:lnSpc>
        <a:spcBef>
          <a:spcPct val="0"/>
        </a:spcBef>
        <a:buNone/>
        <a:defRPr sz="50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9827" indent="-259827" algn="l" defTabSz="1039307" rtl="0" eaLnBrk="1" latinLnBrk="0" hangingPunct="1">
        <a:lnSpc>
          <a:spcPct val="90000"/>
        </a:lnSpc>
        <a:spcBef>
          <a:spcPts val="1137"/>
        </a:spcBef>
        <a:buFont typeface="Arial" panose="020B0604020202020204" pitchFamily="34" charset="0"/>
        <a:buChar char="•"/>
        <a:defRPr sz="3182" kern="1200">
          <a:solidFill>
            <a:schemeClr val="tx1"/>
          </a:solidFill>
          <a:latin typeface="+mn-lt"/>
          <a:ea typeface="+mn-ea"/>
          <a:cs typeface="+mn-cs"/>
        </a:defRPr>
      </a:lvl1pPr>
      <a:lvl2pPr marL="779480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728" kern="1200">
          <a:solidFill>
            <a:schemeClr val="tx1"/>
          </a:solidFill>
          <a:latin typeface="+mn-lt"/>
          <a:ea typeface="+mn-ea"/>
          <a:cs typeface="+mn-cs"/>
        </a:defRPr>
      </a:lvl2pPr>
      <a:lvl3pPr marL="1299134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273" kern="1200">
          <a:solidFill>
            <a:schemeClr val="tx1"/>
          </a:solidFill>
          <a:latin typeface="+mn-lt"/>
          <a:ea typeface="+mn-ea"/>
          <a:cs typeface="+mn-cs"/>
        </a:defRPr>
      </a:lvl3pPr>
      <a:lvl4pPr marL="1818787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4pPr>
      <a:lvl5pPr marL="2338441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5pPr>
      <a:lvl6pPr marL="2858094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6pPr>
      <a:lvl7pPr marL="3377748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7pPr>
      <a:lvl8pPr marL="3897401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8pPr>
      <a:lvl9pPr marL="4417055" indent="-259827" algn="l" defTabSz="1039307" rtl="0" eaLnBrk="1" latinLnBrk="0" hangingPunct="1">
        <a:lnSpc>
          <a:spcPct val="90000"/>
        </a:lnSpc>
        <a:spcBef>
          <a:spcPts val="568"/>
        </a:spcBef>
        <a:buFont typeface="Arial" panose="020B0604020202020204" pitchFamily="34" charset="0"/>
        <a:buChar char="•"/>
        <a:defRPr sz="20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1pPr>
      <a:lvl2pPr marL="519654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2pPr>
      <a:lvl3pPr marL="1039307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3pPr>
      <a:lvl4pPr marL="1558961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4pPr>
      <a:lvl5pPr marL="2078614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5pPr>
      <a:lvl6pPr marL="2598268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6pPr>
      <a:lvl7pPr marL="3117921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7pPr>
      <a:lvl8pPr marL="3637575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8pPr>
      <a:lvl9pPr marL="4157228" algn="l" defTabSz="1039307" rtl="0" eaLnBrk="1" latinLnBrk="0" hangingPunct="1">
        <a:defRPr sz="20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10" Type="http://schemas.openxmlformats.org/officeDocument/2006/relationships/image" Target="../media/image24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iff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36F1DB-A108-2446-B0A0-5EF5461FA1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04404" y="741979"/>
            <a:ext cx="8834359" cy="4392742"/>
          </a:xfrm>
        </p:spPr>
        <p:txBody>
          <a:bodyPr>
            <a:normAutofit/>
          </a:bodyPr>
          <a:lstStyle/>
          <a:p>
            <a:r>
              <a:rPr lang="en-GB" sz="2800" b="1" dirty="0"/>
              <a:t>Impact of </a:t>
            </a:r>
            <a:r>
              <a:rPr lang="en-GB" sz="2800" b="1" i="1" dirty="0" err="1"/>
              <a:t>Wuchereria</a:t>
            </a:r>
            <a:r>
              <a:rPr lang="en-GB" sz="2800" b="1" i="1" dirty="0"/>
              <a:t> </a:t>
            </a:r>
            <a:r>
              <a:rPr lang="en-GB" sz="2800" b="1" i="1" dirty="0" err="1"/>
              <a:t>bancrofti</a:t>
            </a:r>
            <a:r>
              <a:rPr lang="en-GB" sz="2800" b="1" dirty="0"/>
              <a:t> infection on cervical mucosal immunity and human papillomavirus prevalence in women from </a:t>
            </a:r>
            <a:r>
              <a:rPr lang="en-GB" sz="2800" b="1" dirty="0" err="1"/>
              <a:t>Lindi</a:t>
            </a:r>
            <a:r>
              <a:rPr lang="en-GB" sz="2800" b="1" dirty="0"/>
              <a:t> and Mbeya regions, Tanzania. </a:t>
            </a:r>
            <a:br>
              <a:rPr lang="en-GB" sz="2800" b="1" dirty="0"/>
            </a:br>
            <a:br>
              <a:rPr lang="en-GB" sz="2800" b="1" dirty="0"/>
            </a:br>
            <a:br>
              <a:rPr lang="en-GB" sz="2800" b="1" dirty="0"/>
            </a:br>
            <a:r>
              <a:rPr lang="en-GB" sz="2800" b="1" dirty="0"/>
              <a:t>Supplementary Figures</a:t>
            </a:r>
            <a:br>
              <a:rPr lang="en-US" sz="2800" dirty="0"/>
            </a:br>
            <a:endParaRPr lang="en-GB" sz="2800" dirty="0"/>
          </a:p>
        </p:txBody>
      </p:sp>
    </p:spTree>
    <p:extLst>
      <p:ext uri="{BB962C8B-B14F-4D97-AF65-F5344CB8AC3E}">
        <p14:creationId xmlns:p14="http://schemas.microsoft.com/office/powerpoint/2010/main" val="1096747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37458856-E94B-6B43-B0E5-F7944C8CF0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1782" y="728588"/>
            <a:ext cx="2934646" cy="206583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6C3F3B3-E13E-FDE3-B481-28EC74BDD2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29440" y="728588"/>
            <a:ext cx="2876723" cy="208996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54F7A8F-B579-8D3E-625B-5F795C4DEC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69175" y="752720"/>
            <a:ext cx="3111299" cy="201023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DE8337B-123C-456B-6CC0-3CE5FF89FD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97639" y="728587"/>
            <a:ext cx="2858542" cy="2065837"/>
          </a:xfrm>
          <a:prstGeom prst="rect">
            <a:avLst/>
          </a:prstGeom>
        </p:spPr>
      </p:pic>
      <p:sp>
        <p:nvSpPr>
          <p:cNvPr id="6" name="TextBox 12">
            <a:extLst>
              <a:ext uri="{FF2B5EF4-FFF2-40B4-BE49-F238E27FC236}">
                <a16:creationId xmlns:a16="http://schemas.microsoft.com/office/drawing/2014/main" id="{689A8B06-FE84-4E30-82EB-4146664E44F2}"/>
              </a:ext>
            </a:extLst>
          </p:cNvPr>
          <p:cNvSpPr txBox="1"/>
          <p:nvPr/>
        </p:nvSpPr>
        <p:spPr>
          <a:xfrm>
            <a:off x="281240" y="4148138"/>
            <a:ext cx="9104060" cy="11627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: </a:t>
            </a:r>
            <a:r>
              <a:rPr lang="en-GB" sz="14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Frequencies</a:t>
            </a:r>
            <a:r>
              <a:rPr lang="en-GB" sz="1400" dirty="0">
                <a:effectLst/>
                <a:latin typeface="Aptos"/>
                <a:ea typeface="Calibri" panose="020F0502020204030204" pitchFamily="34" charset="0"/>
                <a:cs typeface="Calibri" panose="020F0502020204030204" pitchFamily="34" charset="0"/>
              </a:rPr>
              <a:t> of naïve, </a:t>
            </a:r>
            <a:r>
              <a:rPr lang="en-GB" sz="1400" dirty="0"/>
              <a:t>central memory, effector memory and terminally differentiated </a:t>
            </a:r>
            <a:r>
              <a:rPr lang="en-GB" sz="1400" dirty="0">
                <a:effectLst/>
                <a:latin typeface="Aptos"/>
                <a:ea typeface="Calibri" panose="020F0502020204030204" pitchFamily="34" charset="0"/>
                <a:cs typeface="Calibri" panose="020F0502020204030204" pitchFamily="34" charset="0"/>
              </a:rPr>
              <a:t>memory CD4</a:t>
            </a:r>
            <a:r>
              <a:rPr lang="en-GB" sz="1400" baseline="30000" dirty="0">
                <a:effectLst/>
                <a:latin typeface="Aptos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GB" sz="1400" dirty="0">
                <a:effectLst/>
                <a:latin typeface="Aptos"/>
                <a:ea typeface="Calibri" panose="020F0502020204030204" pitchFamily="34" charset="0"/>
                <a:cs typeface="Calibri" panose="020F0502020204030204" pitchFamily="34" charset="0"/>
              </a:rPr>
              <a:t> T cells stratified by age groups </a:t>
            </a:r>
            <a:r>
              <a:rPr lang="en-GB" sz="1400" dirty="0"/>
              <a:t>between WB+ and WB- women in the peripheral blood (14 - &lt;25 WB+ n=4, 14 - &lt;25 WB- n=12, 25 - &lt;45WB+ n=16, 25 - &lt;45WB- n=8, 45 - &lt;65WB+ n=6, 45 - &lt;65WB- n=5).  Groups were compared using Mann-Whitney U-test.    </a:t>
            </a:r>
            <a:endParaRPr lang="en-US" sz="1400" dirty="0"/>
          </a:p>
          <a:p>
            <a:r>
              <a:rPr lang="en-GB" sz="1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n-US" sz="1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852118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AB63AA8-2D0D-E720-CE64-2EB70484CC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3829" y="141837"/>
            <a:ext cx="2284818" cy="220795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6BF7D02-B396-00E6-3EA0-400B564D2C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05519" y="141838"/>
            <a:ext cx="2284818" cy="220795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BFBFD8A-C356-C315-5170-56327A7387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75219" y="141839"/>
            <a:ext cx="2284818" cy="220795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9C010CD-162B-8071-D503-0E3BC5C552E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56249" y="2437351"/>
            <a:ext cx="2242894" cy="220795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1CACC0E-5366-5B80-421D-9A07022133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60037" y="2437352"/>
            <a:ext cx="2284818" cy="220795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E66B603-34CF-C82B-46FD-F4F4F74ABBC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23198" y="4732865"/>
            <a:ext cx="2284818" cy="220795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73CE030-ACEF-A790-5AB0-20435A71362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860037" y="4732865"/>
            <a:ext cx="2284818" cy="2207958"/>
          </a:xfrm>
          <a:prstGeom prst="rect">
            <a:avLst/>
          </a:prstGeom>
        </p:spPr>
      </p:pic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F8AC2F0E-CCFF-D668-6766-B83876FFDF79}"/>
              </a:ext>
            </a:extLst>
          </p:cNvPr>
          <p:cNvCxnSpPr/>
          <p:nvPr/>
        </p:nvCxnSpPr>
        <p:spPr>
          <a:xfrm>
            <a:off x="1711842" y="1828800"/>
            <a:ext cx="20520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71CC1E94-CFDA-8A40-4C76-F3D64C1337C6}"/>
              </a:ext>
            </a:extLst>
          </p:cNvPr>
          <p:cNvCxnSpPr/>
          <p:nvPr/>
        </p:nvCxnSpPr>
        <p:spPr>
          <a:xfrm>
            <a:off x="4093535" y="1828800"/>
            <a:ext cx="19351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15B9B3B4-400E-BC4D-207D-CC61CC81BC11}"/>
              </a:ext>
            </a:extLst>
          </p:cNvPr>
          <p:cNvCxnSpPr/>
          <p:nvPr/>
        </p:nvCxnSpPr>
        <p:spPr>
          <a:xfrm>
            <a:off x="7369175" y="2020186"/>
            <a:ext cx="0" cy="5103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BF0FA6FC-7E91-97F8-38FA-0765A3E1A06B}"/>
              </a:ext>
            </a:extLst>
          </p:cNvPr>
          <p:cNvCxnSpPr/>
          <p:nvPr/>
        </p:nvCxnSpPr>
        <p:spPr>
          <a:xfrm>
            <a:off x="7155712" y="4148138"/>
            <a:ext cx="12014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64E32496-9BD5-D135-4842-3AB4F705667B}"/>
              </a:ext>
            </a:extLst>
          </p:cNvPr>
          <p:cNvCxnSpPr/>
          <p:nvPr/>
        </p:nvCxnSpPr>
        <p:spPr>
          <a:xfrm>
            <a:off x="6996223" y="4316819"/>
            <a:ext cx="0" cy="52099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B1C2C0C-D4BF-1299-202D-B564F79F1A5B}"/>
              </a:ext>
            </a:extLst>
          </p:cNvPr>
          <p:cNvCxnSpPr/>
          <p:nvPr/>
        </p:nvCxnSpPr>
        <p:spPr>
          <a:xfrm>
            <a:off x="6539023" y="6308725"/>
            <a:ext cx="18181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B0E312E1-7FB5-E156-CB7D-D32773ADB511}"/>
              </a:ext>
            </a:extLst>
          </p:cNvPr>
          <p:cNvSpPr txBox="1"/>
          <p:nvPr/>
        </p:nvSpPr>
        <p:spPr>
          <a:xfrm>
            <a:off x="803829" y="8864609"/>
            <a:ext cx="89624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GB" sz="1200" b="1" dirty="0"/>
              <a:t>Figure S2</a:t>
            </a:r>
            <a:r>
              <a:rPr lang="en-GB" sz="1200" dirty="0"/>
              <a:t>: Gating strategy for peripheral blood </a:t>
            </a:r>
            <a:r>
              <a:rPr lang="en-GB" sz="1200" dirty="0">
                <a:latin typeface="Aptos" panose="020B0004020202020204" pitchFamily="34" charset="0"/>
                <a:cs typeface="Times New Roman" panose="02020603050405020304" pitchFamily="18" charset="0"/>
              </a:rPr>
              <a:t>CCR5</a:t>
            </a:r>
            <a:r>
              <a:rPr lang="en-GB" sz="1200" dirty="0"/>
              <a:t> on total and memory CD4 T cells</a:t>
            </a:r>
            <a:endParaRPr lang="en-TZ" sz="1200" dirty="0"/>
          </a:p>
        </p:txBody>
      </p:sp>
    </p:spTree>
    <p:extLst>
      <p:ext uri="{BB962C8B-B14F-4D97-AF65-F5344CB8AC3E}">
        <p14:creationId xmlns:p14="http://schemas.microsoft.com/office/powerpoint/2010/main" val="2763360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C6D5ED8-EE4A-9B82-80A4-7274296EDCE5}"/>
              </a:ext>
            </a:extLst>
          </p:cNvPr>
          <p:cNvSpPr txBox="1"/>
          <p:nvPr/>
        </p:nvSpPr>
        <p:spPr>
          <a:xfrm>
            <a:off x="285868" y="4662431"/>
            <a:ext cx="9645532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</a:t>
            </a:r>
            <a:r>
              <a:rPr lang="en-GB" sz="1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equencies of CD4 T cells expressing CCR5 in the cervical mucosal categorised by age.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requencies of CD4 T cells expressing CCR5</a:t>
            </a:r>
            <a:r>
              <a:rPr lang="en-GB" sz="14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A), memory CD4 T cells expressing CCR5 (B) and activated memory CD4 T cells expressing CCR5 (C) between WB+ and WB- among three age groups: 14- &lt;25 (n=3 WB+, 7 WB-), 25-&lt;45 (n=15 WB+, 8 WB-) and 45-&lt;65 (n= 5 WB+, 2 WB-). Groups were compared using Mann-Whitney U-test. </a:t>
            </a:r>
            <a:endParaRPr lang="en-US" sz="1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F9EA43F-59C0-D3EA-5BB9-A87746A59A50}"/>
              </a:ext>
            </a:extLst>
          </p:cNvPr>
          <p:cNvSpPr txBox="1"/>
          <p:nvPr/>
        </p:nvSpPr>
        <p:spPr>
          <a:xfrm>
            <a:off x="646204" y="973237"/>
            <a:ext cx="357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4F4BD7B-1E2F-F4D4-BFA5-52A334DDEE7B}"/>
              </a:ext>
            </a:extLst>
          </p:cNvPr>
          <p:cNvSpPr txBox="1"/>
          <p:nvPr/>
        </p:nvSpPr>
        <p:spPr>
          <a:xfrm>
            <a:off x="3380945" y="98170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71E1B5-9EB0-93DE-A39C-6A2F7909D129}"/>
              </a:ext>
            </a:extLst>
          </p:cNvPr>
          <p:cNvSpPr txBox="1"/>
          <p:nvPr/>
        </p:nvSpPr>
        <p:spPr>
          <a:xfrm>
            <a:off x="6115686" y="98170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4024FA8-FB14-01B7-5B58-BC2DF53ADDEE}"/>
              </a:ext>
            </a:extLst>
          </p:cNvPr>
          <p:cNvCxnSpPr>
            <a:cxnSpLocks/>
          </p:cNvCxnSpPr>
          <p:nvPr/>
        </p:nvCxnSpPr>
        <p:spPr>
          <a:xfrm>
            <a:off x="1154288" y="3714506"/>
            <a:ext cx="624557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C7E2F705-C775-4E2E-54AB-CD77255B30EE}"/>
              </a:ext>
            </a:extLst>
          </p:cNvPr>
          <p:cNvSpPr txBox="1"/>
          <p:nvPr/>
        </p:nvSpPr>
        <p:spPr>
          <a:xfrm>
            <a:off x="3866728" y="3733078"/>
            <a:ext cx="106087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b="1" dirty="0"/>
              <a:t>Age groups</a:t>
            </a:r>
            <a:r>
              <a:rPr lang="en-GB" sz="1000" b="1" dirty="0"/>
              <a:t>                      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E55CC50C-2B33-5E3B-9A82-D28591800A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33868" y="1294680"/>
            <a:ext cx="2857500" cy="23114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F53D96CD-168E-54F9-2F62-1258D6E763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11709" y="1297137"/>
            <a:ext cx="2844800" cy="23114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9E0F75A-3C72-9A13-3E4B-AA3D0A387C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45745" y="1080607"/>
            <a:ext cx="3441700" cy="25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44196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9D4AA39-C93A-54E7-F84E-EF85FBA44BD7}"/>
              </a:ext>
            </a:extLst>
          </p:cNvPr>
          <p:cNvSpPr txBox="1"/>
          <p:nvPr/>
        </p:nvSpPr>
        <p:spPr>
          <a:xfrm>
            <a:off x="292395" y="6963930"/>
            <a:ext cx="9489557" cy="7736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. Mean Fluorescence Intensity (MFI) of CCR5+ in relation to </a:t>
            </a:r>
            <a:r>
              <a:rPr lang="en-GB" sz="14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B</a:t>
            </a:r>
            <a:r>
              <a:rPr lang="en-GB" sz="14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ection status</a:t>
            </a:r>
            <a:r>
              <a:rPr lang="en-GB" sz="1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FI of CCR5+ in the total CD4 T cells (A) and in the memory CD4 T cells (B). Each grey square and blue diamond represent a participant and the horizontal line is the group median. Groups were compared using Mann-Whitney U-test. </a:t>
            </a:r>
            <a:endParaRPr lang="en-TZ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F25E23B-864B-38B7-E5C0-A42264E505B4}"/>
              </a:ext>
            </a:extLst>
          </p:cNvPr>
          <p:cNvGrpSpPr/>
          <p:nvPr/>
        </p:nvGrpSpPr>
        <p:grpSpPr>
          <a:xfrm>
            <a:off x="635798" y="1440254"/>
            <a:ext cx="6969653" cy="3412110"/>
            <a:chOff x="635798" y="1440254"/>
            <a:chExt cx="6969653" cy="3412110"/>
          </a:xfrm>
        </p:grpSpPr>
        <p:sp>
          <p:nvSpPr>
            <p:cNvPr id="8" name="Text Box 12">
              <a:extLst>
                <a:ext uri="{FF2B5EF4-FFF2-40B4-BE49-F238E27FC236}">
                  <a16:creationId xmlns:a16="http://schemas.microsoft.com/office/drawing/2014/main" id="{0A1CC563-5154-1241-8C60-E72A44EA23A4}"/>
                </a:ext>
              </a:extLst>
            </p:cNvPr>
            <p:cNvSpPr txBox="1"/>
            <p:nvPr/>
          </p:nvSpPr>
          <p:spPr>
            <a:xfrm>
              <a:off x="5723648" y="1681529"/>
              <a:ext cx="1881803" cy="748310"/>
            </a:xfrm>
            <a:prstGeom prst="rect">
              <a:avLst/>
            </a:prstGeom>
            <a:solidFill>
              <a:sysClr val="window" lastClr="FFFFFF"/>
            </a:solidFill>
            <a:ln w="6350">
              <a:noFill/>
            </a:ln>
          </p:spPr>
          <p:txBody>
            <a:bodyPr rot="0" spcFirstLastPara="0" vert="horz" wrap="square" lIns="131272" tIns="65637" rIns="131272" bIns="65637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146"/>
                </a:spcAft>
              </a:pPr>
              <a:r>
                <a:rPr lang="en-GB" sz="1200" b="1" dirty="0" err="1">
                  <a:ea typeface="Calibri" panose="020F0502020204030204" pitchFamily="34" charset="0"/>
                  <a:cs typeface="Times New Roman" panose="02020603050405020304" pitchFamily="18" charset="0"/>
                </a:rPr>
                <a:t>Cx</a:t>
              </a:r>
              <a:r>
                <a:rPr lang="en-GB" sz="1200" b="1" dirty="0">
                  <a:ea typeface="Calibri" panose="020F0502020204030204" pitchFamily="34" charset="0"/>
                  <a:cs typeface="Times New Roman" panose="02020603050405020304" pitchFamily="18" charset="0"/>
                </a:rPr>
                <a:t>: </a:t>
              </a: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cervical mucosa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200" b="1" dirty="0" err="1">
                  <a:ea typeface="Calibri" panose="020F0502020204030204" pitchFamily="34" charset="0"/>
                  <a:cs typeface="Times New Roman" panose="02020603050405020304" pitchFamily="18" charset="0"/>
                </a:rPr>
                <a:t>Pb</a:t>
              </a:r>
              <a:r>
                <a:rPr lang="en-GB" sz="1200" b="1" dirty="0">
                  <a:ea typeface="Calibri" panose="020F0502020204030204" pitchFamily="34" charset="0"/>
                  <a:cs typeface="Times New Roman" panose="02020603050405020304" pitchFamily="18" charset="0"/>
                </a:rPr>
                <a:t>: </a:t>
              </a: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peripheral blood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8A97034-37BA-DC4F-987F-AAB4A7BE69A1}"/>
                </a:ext>
              </a:extLst>
            </p:cNvPr>
            <p:cNvSpPr txBox="1"/>
            <p:nvPr/>
          </p:nvSpPr>
          <p:spPr>
            <a:xfrm>
              <a:off x="735464" y="1440254"/>
              <a:ext cx="3575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4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421D48D-082E-424A-BD7E-AECD8DBB60E5}"/>
                </a:ext>
              </a:extLst>
            </p:cNvPr>
            <p:cNvSpPr txBox="1"/>
            <p:nvPr/>
          </p:nvSpPr>
          <p:spPr>
            <a:xfrm>
              <a:off x="3461574" y="1446779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4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D675AA9A-0920-42C7-2BE5-1692F8AA0D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5798" y="2032964"/>
              <a:ext cx="2514600" cy="28194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CBD5D5B-193D-1CC5-B476-0C29AA9C5B2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27943" y="1943004"/>
              <a:ext cx="2514600" cy="2895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826588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8962BB9-B40C-54D9-EDF6-E93BF42815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99024"/>
            <a:ext cx="2598354" cy="22953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26E5C11-9192-5077-28FC-CC73F13E28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98327" y="299024"/>
            <a:ext cx="2598354" cy="22953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1E5AD1D-FA8F-F98B-4182-4B8F1FAB2C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16817" y="299024"/>
            <a:ext cx="2559669" cy="22953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93DA177-2DDC-E8EC-89F6-1BAFB6D5BF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65597" y="341610"/>
            <a:ext cx="2598354" cy="22953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A5091A7-EB8C-CAE8-A9D1-FC5C8901C9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49276" y="3369192"/>
            <a:ext cx="2598354" cy="22953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C72B5B1-4BFB-1142-2641-B3AC8703A44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35357" y="3369192"/>
            <a:ext cx="2598354" cy="22953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E1E5324-C1F0-522D-1B0E-FED3597844A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67243" y="5993018"/>
            <a:ext cx="2598354" cy="229532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A1395A93-1C9C-F486-918B-F418C6F0757D}"/>
              </a:ext>
            </a:extLst>
          </p:cNvPr>
          <p:cNvSpPr txBox="1"/>
          <p:nvPr/>
        </p:nvSpPr>
        <p:spPr>
          <a:xfrm>
            <a:off x="695056" y="9440002"/>
            <a:ext cx="7172553" cy="259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87" b="1" dirty="0"/>
              <a:t>Figure S5</a:t>
            </a:r>
            <a:r>
              <a:rPr lang="en-GB" sz="1087" dirty="0"/>
              <a:t>: Gating strategies for peripheral blood </a:t>
            </a:r>
            <a:r>
              <a:rPr lang="en-GB" sz="1087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α4β7</a:t>
            </a:r>
            <a:r>
              <a:rPr lang="en-GB" sz="1087" dirty="0"/>
              <a:t> on total, memory and activated memory CD4 T cells</a:t>
            </a:r>
            <a:endParaRPr lang="en-TZ" sz="1087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E137E8B-ABF2-9E1E-8BDD-EFC7C09E062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765597" y="5993018"/>
            <a:ext cx="2516094" cy="2431454"/>
          </a:xfrm>
          <a:prstGeom prst="rect">
            <a:avLst/>
          </a:prstGeom>
        </p:spPr>
      </p:pic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367A0FBF-CBB7-FCB8-0971-936BDAFCE7FB}"/>
              </a:ext>
            </a:extLst>
          </p:cNvPr>
          <p:cNvCxnSpPr/>
          <p:nvPr/>
        </p:nvCxnSpPr>
        <p:spPr>
          <a:xfrm>
            <a:off x="7198242" y="1279525"/>
            <a:ext cx="101009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1CE49622-6FC2-0891-3565-36D1790064C3}"/>
              </a:ext>
            </a:extLst>
          </p:cNvPr>
          <p:cNvCxnSpPr/>
          <p:nvPr/>
        </p:nvCxnSpPr>
        <p:spPr>
          <a:xfrm>
            <a:off x="956930" y="2115879"/>
            <a:ext cx="211488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9D0F064-5042-914B-58B0-45A801EE49FF}"/>
              </a:ext>
            </a:extLst>
          </p:cNvPr>
          <p:cNvCxnSpPr/>
          <p:nvPr/>
        </p:nvCxnSpPr>
        <p:spPr>
          <a:xfrm>
            <a:off x="3455581" y="2115879"/>
            <a:ext cx="21796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7E1D190A-BD3B-EDF0-4838-C04583D5A6EC}"/>
              </a:ext>
            </a:extLst>
          </p:cNvPr>
          <p:cNvCxnSpPr/>
          <p:nvPr/>
        </p:nvCxnSpPr>
        <p:spPr>
          <a:xfrm>
            <a:off x="6868633" y="1605516"/>
            <a:ext cx="0" cy="18500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145BE203-0F81-6AFE-C36F-F0957879B7E6}"/>
              </a:ext>
            </a:extLst>
          </p:cNvPr>
          <p:cNvCxnSpPr/>
          <p:nvPr/>
        </p:nvCxnSpPr>
        <p:spPr>
          <a:xfrm>
            <a:off x="6613451" y="5050465"/>
            <a:ext cx="15948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A985F56F-7847-8EEF-3EC7-1C1954A1FE6C}"/>
              </a:ext>
            </a:extLst>
          </p:cNvPr>
          <p:cNvCxnSpPr/>
          <p:nvPr/>
        </p:nvCxnSpPr>
        <p:spPr>
          <a:xfrm>
            <a:off x="7369175" y="7751135"/>
            <a:ext cx="9348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2835118F-EE78-9035-ACD1-FEB0320EE34F}"/>
              </a:ext>
            </a:extLst>
          </p:cNvPr>
          <p:cNvCxnSpPr/>
          <p:nvPr/>
        </p:nvCxnSpPr>
        <p:spPr>
          <a:xfrm>
            <a:off x="6188075" y="5348177"/>
            <a:ext cx="0" cy="73194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984365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B8E21726-C4DD-777A-6E22-AD01F2A07800}"/>
              </a:ext>
            </a:extLst>
          </p:cNvPr>
          <p:cNvSpPr txBox="1"/>
          <p:nvPr/>
        </p:nvSpPr>
        <p:spPr>
          <a:xfrm>
            <a:off x="580736" y="9051171"/>
            <a:ext cx="968910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105009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 Frequencies of α4β7</a:t>
            </a:r>
            <a:r>
              <a:rPr lang="en-GB" sz="14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4 T cells in cervical mucosal and peripheral blood in relation to </a:t>
            </a:r>
            <a:r>
              <a:rPr lang="en-GB" sz="14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B</a:t>
            </a:r>
            <a:r>
              <a:rPr lang="en-GB" sz="14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fection status</a:t>
            </a:r>
            <a:r>
              <a:rPr lang="en-GB" sz="1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presentative flow plots and a graph comparing frequencies of 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</a:rPr>
              <a:t>m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mory CD 4 T cells (A) and Memory activated CD4 T cells (B) expressing α4β7 in the cervical mucosa and peripheral blood from WB+ and WB- groups. </a:t>
            </a:r>
            <a:r>
              <a:rPr lang="en-GB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x:WB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+ n=23 , </a:t>
            </a:r>
            <a:r>
              <a:rPr lang="en-GB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x:WB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 n=17, Pb:WB+ n=26, and Pb:WB- n=25. Each grey square and blue diamond represent a participant and a horizontal line is the group median. Groups were compared using Mann-Whitney U-test. </a:t>
            </a:r>
            <a:endParaRPr lang="en-US" sz="1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9E9E2C0B-BF49-4884-482F-F757E6369FD8}"/>
              </a:ext>
            </a:extLst>
          </p:cNvPr>
          <p:cNvGrpSpPr/>
          <p:nvPr/>
        </p:nvGrpSpPr>
        <p:grpSpPr>
          <a:xfrm>
            <a:off x="434084" y="1238238"/>
            <a:ext cx="9927002" cy="6442086"/>
            <a:chOff x="434084" y="1238238"/>
            <a:chExt cx="9927002" cy="6442086"/>
          </a:xfrm>
        </p:grpSpPr>
        <p:pic>
          <p:nvPicPr>
            <p:cNvPr id="15" name="Picture 14" descr="A graph with numbers and dots&#10;&#10;Description automatically generated">
              <a:extLst>
                <a:ext uri="{FF2B5EF4-FFF2-40B4-BE49-F238E27FC236}">
                  <a16:creationId xmlns:a16="http://schemas.microsoft.com/office/drawing/2014/main" id="{AD579589-5CF9-38F8-2A7B-1E66696C4E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70472" y="1596695"/>
              <a:ext cx="2715561" cy="2377122"/>
            </a:xfrm>
            <a:prstGeom prst="rect">
              <a:avLst/>
            </a:prstGeom>
          </p:spPr>
        </p:pic>
        <p:sp>
          <p:nvSpPr>
            <p:cNvPr id="16" name="Text Box 12">
              <a:extLst>
                <a:ext uri="{FF2B5EF4-FFF2-40B4-BE49-F238E27FC236}">
                  <a16:creationId xmlns:a16="http://schemas.microsoft.com/office/drawing/2014/main" id="{3FA5B20E-094D-EF08-A5FF-DFE61CE94534}"/>
                </a:ext>
              </a:extLst>
            </p:cNvPr>
            <p:cNvSpPr txBox="1"/>
            <p:nvPr/>
          </p:nvSpPr>
          <p:spPr>
            <a:xfrm>
              <a:off x="8636997" y="1373915"/>
              <a:ext cx="1724089" cy="796106"/>
            </a:xfrm>
            <a:prstGeom prst="rect">
              <a:avLst/>
            </a:prstGeom>
            <a:solidFill>
              <a:sysClr val="window" lastClr="FFFFFF"/>
            </a:solidFill>
            <a:ln w="6350">
              <a:noFill/>
            </a:ln>
          </p:spPr>
          <p:txBody>
            <a:bodyPr rot="0" spcFirstLastPara="0" vert="horz" wrap="square" lIns="131272" tIns="65637" rIns="131272" bIns="65637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146"/>
                </a:spcAft>
              </a:pPr>
              <a:r>
                <a:rPr lang="en-GB" sz="1100" b="1" dirty="0" err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x</a:t>
              </a:r>
              <a:r>
                <a:rPr lang="en-GB" sz="11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: </a:t>
              </a:r>
              <a:r>
                <a:rPr lang="en-GB" sz="11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ervical mucosa</a:t>
              </a:r>
              <a:endPara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100" b="1" dirty="0" err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b</a:t>
              </a:r>
              <a:r>
                <a:rPr lang="en-GB" sz="11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: </a:t>
              </a:r>
              <a:r>
                <a:rPr lang="en-GB" sz="11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eripheral blood</a:t>
              </a:r>
              <a:endPara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spcAft>
                  <a:spcPts val="1146"/>
                </a:spcAft>
              </a:pPr>
              <a:r>
                <a:rPr lang="en-GB" sz="1200" dirty="0"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  <a:endParaRPr lang="en-US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C0AEE73-7683-7A64-E2CD-03AAFC1D897D}"/>
                </a:ext>
              </a:extLst>
            </p:cNvPr>
            <p:cNvSpPr txBox="1"/>
            <p:nvPr/>
          </p:nvSpPr>
          <p:spPr>
            <a:xfrm>
              <a:off x="1226498" y="1238238"/>
              <a:ext cx="189464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Cervical mucosa</a:t>
              </a:r>
            </a:p>
            <a:p>
              <a:endParaRPr lang="en-GB" sz="1200" b="1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86070D2-0208-8F02-AC59-9D4159872AFB}"/>
                </a:ext>
              </a:extLst>
            </p:cNvPr>
            <p:cNvSpPr txBox="1"/>
            <p:nvPr/>
          </p:nvSpPr>
          <p:spPr>
            <a:xfrm>
              <a:off x="3809172" y="1268669"/>
              <a:ext cx="1244600" cy="2769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Peripheral blood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E6E7FE29-2294-4CE9-4C68-2478C408C7A0}"/>
                </a:ext>
              </a:extLst>
            </p:cNvPr>
            <p:cNvCxnSpPr/>
            <p:nvPr/>
          </p:nvCxnSpPr>
          <p:spPr>
            <a:xfrm>
              <a:off x="1226498" y="4140286"/>
              <a:ext cx="483669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C99863B-0D80-4D7B-C8EF-D9F965B2E06A}"/>
                </a:ext>
              </a:extLst>
            </p:cNvPr>
            <p:cNvSpPr txBox="1"/>
            <p:nvPr/>
          </p:nvSpPr>
          <p:spPr>
            <a:xfrm>
              <a:off x="3372458" y="4147407"/>
              <a:ext cx="13252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</a:rPr>
                <a:t>α4β7</a:t>
              </a:r>
              <a:endParaRPr lang="en-TZ" sz="1200" b="1" dirty="0"/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03971695-5FD5-35BA-AF7B-A2B63AAFED9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47835" y="1568264"/>
              <a:ext cx="2546838" cy="2400308"/>
            </a:xfrm>
            <a:prstGeom prst="rect">
              <a:avLst/>
            </a:prstGeom>
          </p:spPr>
        </p:pic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06008B4E-1A67-10DF-8C58-91A627069640}"/>
                </a:ext>
              </a:extLst>
            </p:cNvPr>
            <p:cNvCxnSpPr/>
            <p:nvPr/>
          </p:nvCxnSpPr>
          <p:spPr>
            <a:xfrm>
              <a:off x="6063197" y="3391780"/>
              <a:ext cx="68277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292E150-905A-316D-7478-334B02007989}"/>
                </a:ext>
              </a:extLst>
            </p:cNvPr>
            <p:cNvSpPr txBox="1"/>
            <p:nvPr/>
          </p:nvSpPr>
          <p:spPr>
            <a:xfrm>
              <a:off x="2187792" y="2709808"/>
              <a:ext cx="1184666" cy="105156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TZ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C216D42-E2BD-7D14-7DD2-E811F71C4E9B}"/>
                </a:ext>
              </a:extLst>
            </p:cNvPr>
            <p:cNvSpPr txBox="1"/>
            <p:nvPr/>
          </p:nvSpPr>
          <p:spPr>
            <a:xfrm>
              <a:off x="4706140" y="3201620"/>
              <a:ext cx="1357476" cy="58514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TZ" dirty="0"/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B41724C-7740-E96B-BBE0-818E40E61424}"/>
                </a:ext>
              </a:extLst>
            </p:cNvPr>
            <p:cNvGrpSpPr/>
            <p:nvPr/>
          </p:nvGrpSpPr>
          <p:grpSpPr>
            <a:xfrm>
              <a:off x="811300" y="4600862"/>
              <a:ext cx="2632398" cy="2570361"/>
              <a:chOff x="5410200" y="3761601"/>
              <a:chExt cx="2800350" cy="2715399"/>
            </a:xfrm>
          </p:grpSpPr>
          <p:pic>
            <p:nvPicPr>
              <p:cNvPr id="3" name="Picture 4">
                <a:extLst>
                  <a:ext uri="{FF2B5EF4-FFF2-40B4-BE49-F238E27FC236}">
                    <a16:creationId xmlns:a16="http://schemas.microsoft.com/office/drawing/2014/main" id="{68AF5AF8-B1D1-2011-D364-99DE9EBB0EA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47" t="3529" b="17648"/>
              <a:stretch/>
            </p:blipFill>
            <p:spPr bwMode="auto">
              <a:xfrm>
                <a:off x="5410200" y="3924300"/>
                <a:ext cx="2800350" cy="25527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451C0C87-1EC0-037A-3586-B0A73759CDFC}"/>
                  </a:ext>
                </a:extLst>
              </p:cNvPr>
              <p:cNvSpPr txBox="1"/>
              <p:nvPr/>
            </p:nvSpPr>
            <p:spPr>
              <a:xfrm>
                <a:off x="6019800" y="3761601"/>
                <a:ext cx="1981200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GB" sz="800" dirty="0"/>
              </a:p>
            </p:txBody>
          </p:sp>
        </p:grpSp>
        <p:sp>
          <p:nvSpPr>
            <p:cNvPr id="9" name="Rectangle 34">
              <a:extLst>
                <a:ext uri="{FF2B5EF4-FFF2-40B4-BE49-F238E27FC236}">
                  <a16:creationId xmlns:a16="http://schemas.microsoft.com/office/drawing/2014/main" id="{5BFECECA-D4D4-4D68-EE10-E1BB93257D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2115" y="3923678"/>
              <a:ext cx="165407" cy="530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131272" tIns="65637" rIns="131272" bIns="65637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GB" sz="2588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1CBFE14-621E-689F-29B7-E2389039EC5E}"/>
                </a:ext>
              </a:extLst>
            </p:cNvPr>
            <p:cNvSpPr txBox="1"/>
            <p:nvPr/>
          </p:nvSpPr>
          <p:spPr>
            <a:xfrm>
              <a:off x="5128203" y="5689395"/>
              <a:ext cx="562337" cy="3692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l-GR" sz="900" dirty="0"/>
                <a:t>α4β7</a:t>
              </a:r>
              <a:r>
                <a:rPr lang="en-GB" sz="900" dirty="0"/>
                <a:t>+</a:t>
              </a:r>
            </a:p>
            <a:p>
              <a:r>
                <a:rPr lang="en-GB" sz="900" dirty="0"/>
                <a:t>31.8                       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ADC9F11-AA7D-489F-7358-C83438035D68}"/>
                </a:ext>
              </a:extLst>
            </p:cNvPr>
            <p:cNvSpPr txBox="1"/>
            <p:nvPr/>
          </p:nvSpPr>
          <p:spPr>
            <a:xfrm>
              <a:off x="2098959" y="5847215"/>
              <a:ext cx="1257813" cy="1138773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GB" sz="1800" dirty="0"/>
            </a:p>
            <a:p>
              <a:endParaRPr lang="en-GB" sz="1800" dirty="0"/>
            </a:p>
            <a:p>
              <a:endParaRPr lang="en-GB" sz="1800" dirty="0"/>
            </a:p>
            <a:p>
              <a:endParaRPr lang="en-GB" sz="1400" dirty="0"/>
            </a:p>
          </p:txBody>
        </p: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58D13967-B140-6EFD-DED0-C50A873B9B40}"/>
                </a:ext>
              </a:extLst>
            </p:cNvPr>
            <p:cNvGrpSpPr/>
            <p:nvPr/>
          </p:nvGrpSpPr>
          <p:grpSpPr>
            <a:xfrm>
              <a:off x="1775882" y="4798777"/>
              <a:ext cx="4057649" cy="2813017"/>
              <a:chOff x="994362" y="3753140"/>
              <a:chExt cx="4157862" cy="2595412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4C51D33E-3D72-CE22-D271-DC42C381DDD1}"/>
                  </a:ext>
                </a:extLst>
              </p:cNvPr>
              <p:cNvGrpSpPr/>
              <p:nvPr/>
            </p:nvGrpSpPr>
            <p:grpSpPr>
              <a:xfrm>
                <a:off x="2732278" y="3753140"/>
                <a:ext cx="2419946" cy="2410390"/>
                <a:chOff x="2732278" y="3753140"/>
                <a:chExt cx="2419946" cy="2410390"/>
              </a:xfrm>
            </p:grpSpPr>
            <p:pic>
              <p:nvPicPr>
                <p:cNvPr id="48" name="Picture 47">
                  <a:extLst>
                    <a:ext uri="{FF2B5EF4-FFF2-40B4-BE49-F238E27FC236}">
                      <a16:creationId xmlns:a16="http://schemas.microsoft.com/office/drawing/2014/main" id="{188799B8-2FA6-8D85-C8F1-8662405E0A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rcRect l="3428"/>
                <a:stretch/>
              </p:blipFill>
              <p:spPr>
                <a:xfrm>
                  <a:off x="2732278" y="3753140"/>
                  <a:ext cx="2419946" cy="2410390"/>
                </a:xfrm>
                <a:prstGeom prst="rect">
                  <a:avLst/>
                </a:prstGeom>
              </p:spPr>
            </p:pic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B596D364-3521-28C9-7274-765CCCCF68C5}"/>
                    </a:ext>
                  </a:extLst>
                </p:cNvPr>
                <p:cNvSpPr txBox="1"/>
                <p:nvPr/>
              </p:nvSpPr>
              <p:spPr>
                <a:xfrm>
                  <a:off x="3944933" y="5228994"/>
                  <a:ext cx="778903" cy="553738"/>
                </a:xfrm>
                <a:prstGeom prst="rect">
                  <a:avLst/>
                </a:prstGeom>
                <a:noFill/>
                <a:ln w="12700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GB" sz="1100" dirty="0"/>
                </a:p>
                <a:p>
                  <a:endParaRPr lang="en-GB" sz="1100" dirty="0"/>
                </a:p>
                <a:p>
                  <a:endParaRPr lang="en-GB" sz="1100" dirty="0"/>
                </a:p>
              </p:txBody>
            </p:sp>
          </p:grp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E40C04D2-46D8-D9FE-E39C-8F66616B594B}"/>
                  </a:ext>
                </a:extLst>
              </p:cNvPr>
              <p:cNvSpPr txBox="1"/>
              <p:nvPr/>
            </p:nvSpPr>
            <p:spPr>
              <a:xfrm>
                <a:off x="4067806" y="4810297"/>
                <a:ext cx="509938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/>
                  <a:t> α4β7+ </a:t>
                </a:r>
              </a:p>
              <a:p>
                <a:r>
                  <a:rPr lang="en-GB" sz="900" dirty="0"/>
                  <a:t>31.8                   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D583B788-B558-6309-BC7B-AAA55FAAEFC1}"/>
                  </a:ext>
                </a:extLst>
              </p:cNvPr>
              <p:cNvSpPr txBox="1"/>
              <p:nvPr/>
            </p:nvSpPr>
            <p:spPr>
              <a:xfrm>
                <a:off x="994362" y="6092981"/>
                <a:ext cx="3857749" cy="25557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            α4β7                    </a:t>
                </a:r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0081140-7504-94CA-CBEB-A9EAE4EF32E8}"/>
                </a:ext>
              </a:extLst>
            </p:cNvPr>
            <p:cNvSpPr txBox="1"/>
            <p:nvPr/>
          </p:nvSpPr>
          <p:spPr>
            <a:xfrm rot="16200000">
              <a:off x="-25983" y="5827630"/>
              <a:ext cx="119713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             </a:t>
              </a:r>
              <a:r>
                <a:rPr lang="en-GB" sz="1200" b="1" dirty="0"/>
                <a:t>SSC-A</a:t>
              </a:r>
              <a:r>
                <a:rPr lang="en-GB" sz="1000" b="1" dirty="0"/>
                <a:t>                    </a:t>
              </a:r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B2634B6C-A24B-1202-B940-D080EC06F465}"/>
                </a:ext>
              </a:extLst>
            </p:cNvPr>
            <p:cNvCxnSpPr>
              <a:cxnSpLocks/>
            </p:cNvCxnSpPr>
            <p:nvPr/>
          </p:nvCxnSpPr>
          <p:spPr>
            <a:xfrm>
              <a:off x="5368426" y="6471956"/>
              <a:ext cx="131494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AEB81A7-FAAE-8A80-753B-C7A94FB27C25}"/>
                </a:ext>
              </a:extLst>
            </p:cNvPr>
            <p:cNvSpPr txBox="1"/>
            <p:nvPr/>
          </p:nvSpPr>
          <p:spPr>
            <a:xfrm>
              <a:off x="674762" y="4208303"/>
              <a:ext cx="364202" cy="307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4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1C28BB18-2F19-F34D-652A-32F883CD63D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4764" y="5194991"/>
              <a:ext cx="0" cy="141502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B903D6BB-4F62-EBBD-67F0-61F4272DBB3F}"/>
                </a:ext>
              </a:extLst>
            </p:cNvPr>
            <p:cNvCxnSpPr>
              <a:cxnSpLocks/>
            </p:cNvCxnSpPr>
            <p:nvPr/>
          </p:nvCxnSpPr>
          <p:spPr>
            <a:xfrm>
              <a:off x="1858684" y="7306422"/>
              <a:ext cx="355678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D5D1F66-E7C1-4192-2C16-AF73D8845CBC}"/>
                </a:ext>
              </a:extLst>
            </p:cNvPr>
            <p:cNvSpPr txBox="1"/>
            <p:nvPr/>
          </p:nvSpPr>
          <p:spPr>
            <a:xfrm>
              <a:off x="2273609" y="5442410"/>
              <a:ext cx="80863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/>
                <a:t>α4β7+</a:t>
              </a:r>
            </a:p>
            <a:p>
              <a:pPr algn="ctr"/>
              <a:r>
                <a:rPr lang="en-GB" sz="900" dirty="0"/>
                <a:t>39.2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DB2EA56-4B47-73E5-3E14-7A24ED723212}"/>
                </a:ext>
              </a:extLst>
            </p:cNvPr>
            <p:cNvSpPr txBox="1"/>
            <p:nvPr/>
          </p:nvSpPr>
          <p:spPr>
            <a:xfrm>
              <a:off x="674760" y="1278825"/>
              <a:ext cx="3575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4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61B7691-72D7-B092-E5D9-FB9125C0AB37}"/>
                </a:ext>
              </a:extLst>
            </p:cNvPr>
            <p:cNvSpPr txBox="1"/>
            <p:nvPr/>
          </p:nvSpPr>
          <p:spPr>
            <a:xfrm rot="16200000">
              <a:off x="-17517" y="2788083"/>
              <a:ext cx="119713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             </a:t>
              </a:r>
              <a:r>
                <a:rPr lang="en-GB" sz="1200" b="1" dirty="0"/>
                <a:t>SSC-A</a:t>
              </a:r>
              <a:r>
                <a:rPr lang="en-GB" sz="1000" b="1" dirty="0"/>
                <a:t>                    </a:t>
              </a:r>
            </a:p>
          </p:txBody>
        </p: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CD1E9F0A-47F8-84AA-352D-0B969294A38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3230" y="2155444"/>
              <a:ext cx="0" cy="141502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99AE400-5A2D-F27A-77A8-8563EE1DB7F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653438" y="1671958"/>
              <a:ext cx="2413000" cy="27813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3513EFF2-2CAF-89C9-365F-62EB1E64853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657192" y="4886324"/>
              <a:ext cx="2413000" cy="2794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22547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22B945C0-8536-A74C-A572-C71AF6E2EA4E}"/>
              </a:ext>
            </a:extLst>
          </p:cNvPr>
          <p:cNvGrpSpPr/>
          <p:nvPr/>
        </p:nvGrpSpPr>
        <p:grpSpPr>
          <a:xfrm>
            <a:off x="470659" y="979009"/>
            <a:ext cx="8719781" cy="8017600"/>
            <a:chOff x="470659" y="979009"/>
            <a:chExt cx="8719781" cy="8017600"/>
          </a:xfrm>
        </p:grpSpPr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68BBA22E-DF20-BA4D-9269-34CC234E9EC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70659" y="1121239"/>
              <a:ext cx="3012928" cy="24592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3">
              <a:extLst>
                <a:ext uri="{FF2B5EF4-FFF2-40B4-BE49-F238E27FC236}">
                  <a16:creationId xmlns:a16="http://schemas.microsoft.com/office/drawing/2014/main" id="{723A7025-C743-2442-969B-0D2D57A1E82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474629" y="1121239"/>
              <a:ext cx="3037858" cy="24796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4">
              <a:extLst>
                <a:ext uri="{FF2B5EF4-FFF2-40B4-BE49-F238E27FC236}">
                  <a16:creationId xmlns:a16="http://schemas.microsoft.com/office/drawing/2014/main" id="{A71BAB68-21E3-A24C-A20F-15E952DB0B9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52405" y="979009"/>
              <a:ext cx="2521400" cy="2537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5">
              <a:extLst>
                <a:ext uri="{FF2B5EF4-FFF2-40B4-BE49-F238E27FC236}">
                  <a16:creationId xmlns:a16="http://schemas.microsoft.com/office/drawing/2014/main" id="{6EB39CCC-0701-2645-B63F-76E0368935D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5934014" y="3796270"/>
              <a:ext cx="3256426" cy="24001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2">
              <a:extLst>
                <a:ext uri="{FF2B5EF4-FFF2-40B4-BE49-F238E27FC236}">
                  <a16:creationId xmlns:a16="http://schemas.microsoft.com/office/drawing/2014/main" id="{50F7C870-011D-7E4B-ADF1-0B1262CCC97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6346256" y="6569179"/>
              <a:ext cx="2844184" cy="24092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4">
              <a:extLst>
                <a:ext uri="{FF2B5EF4-FFF2-40B4-BE49-F238E27FC236}">
                  <a16:creationId xmlns:a16="http://schemas.microsoft.com/office/drawing/2014/main" id="{5C280887-D11A-0A44-AD47-5CDD10B6CA8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237849" y="3790422"/>
              <a:ext cx="2584893" cy="24556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5">
              <a:extLst>
                <a:ext uri="{FF2B5EF4-FFF2-40B4-BE49-F238E27FC236}">
                  <a16:creationId xmlns:a16="http://schemas.microsoft.com/office/drawing/2014/main" id="{C9CE7FE7-D4FC-B844-A5B1-1880024DA45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250487" y="6391811"/>
              <a:ext cx="2588203" cy="26047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E7B97938-6FCB-CD45-80B8-BDE9DC7A5FF7}"/>
                </a:ext>
              </a:extLst>
            </p:cNvPr>
            <p:cNvCxnSpPr>
              <a:cxnSpLocks/>
            </p:cNvCxnSpPr>
            <p:nvPr/>
          </p:nvCxnSpPr>
          <p:spPr>
            <a:xfrm>
              <a:off x="2583717" y="2732567"/>
              <a:ext cx="127590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646ADA8D-83FF-304F-941C-38A30EC1F11E}"/>
                </a:ext>
              </a:extLst>
            </p:cNvPr>
            <p:cNvCxnSpPr>
              <a:cxnSpLocks/>
            </p:cNvCxnSpPr>
            <p:nvPr/>
          </p:nvCxnSpPr>
          <p:spPr>
            <a:xfrm>
              <a:off x="4692524" y="2736108"/>
              <a:ext cx="225053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4312E39B-D7A7-5442-AA9C-ACAEE5F21B4C}"/>
                </a:ext>
              </a:extLst>
            </p:cNvPr>
            <p:cNvCxnSpPr>
              <a:cxnSpLocks/>
            </p:cNvCxnSpPr>
            <p:nvPr/>
          </p:nvCxnSpPr>
          <p:spPr>
            <a:xfrm>
              <a:off x="7606223" y="3092155"/>
              <a:ext cx="0" cy="69562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31514FA4-05DE-5741-B2AC-AA38AC86B86E}"/>
                </a:ext>
              </a:extLst>
            </p:cNvPr>
            <p:cNvCxnSpPr>
              <a:cxnSpLocks/>
            </p:cNvCxnSpPr>
            <p:nvPr/>
          </p:nvCxnSpPr>
          <p:spPr>
            <a:xfrm>
              <a:off x="7683800" y="5753847"/>
              <a:ext cx="0" cy="81533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7C8F5B5A-AC86-9F4C-ACF1-8E5099CF7F4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8692" y="5753847"/>
              <a:ext cx="1861056" cy="145502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2F89084D-C040-4548-ABF1-1B9965874B7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782178" y="5273317"/>
              <a:ext cx="1901622" cy="48190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B41CB2B5-FCC7-E53C-4E66-3C64C1448EF1}"/>
              </a:ext>
            </a:extLst>
          </p:cNvPr>
          <p:cNvSpPr txBox="1"/>
          <p:nvPr/>
        </p:nvSpPr>
        <p:spPr>
          <a:xfrm>
            <a:off x="1196163" y="9633196"/>
            <a:ext cx="845819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7: </a:t>
            </a:r>
            <a:r>
              <a:rPr lang="en-GB" sz="1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ating strategies for the mucosal CD4 T cells and the two populations of γδ T cells.</a:t>
            </a:r>
            <a:endParaRPr lang="en-US" sz="1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79206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71</Words>
  <Application>Microsoft Office PowerPoint</Application>
  <PresentationFormat>Benutzerdefiniert</PresentationFormat>
  <Paragraphs>57</Paragraphs>
  <Slides>8</Slides>
  <Notes>8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Office Theme</vt:lpstr>
      <vt:lpstr>Impact of Wuchereria bancrofti infection on cervical mucosal immunity and human papillomavirus prevalence in women from Lindi and Mbeya regions, Tanzania.    Supplementary Figures 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Marandu</dc:creator>
  <cp:lastModifiedBy>Inge Kroidl</cp:lastModifiedBy>
  <cp:revision>476</cp:revision>
  <dcterms:created xsi:type="dcterms:W3CDTF">2024-02-26T13:26:33Z</dcterms:created>
  <dcterms:modified xsi:type="dcterms:W3CDTF">2025-08-17T08:47:22Z</dcterms:modified>
</cp:coreProperties>
</file>